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6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>
        <p:scale>
          <a:sx n="119" d="100"/>
          <a:sy n="119" d="100"/>
        </p:scale>
        <p:origin x="760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FAC06-3D8C-9A42-8113-5122BA6D8A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07991E-43B7-4847-A4DB-FF967F1228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452829-5698-E54E-BCA5-7ADB971CA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72C694-6195-C74E-A7A1-9A4D1B441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27381-D630-F344-A5E7-998593A13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019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30288-D984-1643-AD00-13A2949926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43BCB1-4241-4943-A17A-9F63EE2D15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DB30D3-011F-3C49-A923-E5DDD34FB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A806BD-1242-7547-9292-0828A7394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8AE893-1192-574B-862C-AEE118C36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21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C22751-EF89-5C4F-B81E-AA973ABD69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771692-B9D5-0D46-83BA-49C73D53B8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7644E-4FC1-ED46-A871-464C02956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6B0E0-00A6-0643-A03F-2DB48823D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55693-3FE6-0B4A-B6EC-C253D937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692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7D569A-6CAB-554B-803B-6D9E1FF2B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0AF57F-0E82-C44D-843A-A67DD8500D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404BE8-D58D-D14F-8A4A-55EF9856B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00FD1-C50C-814B-9A24-36DA14680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52EEC-644C-5945-B1C9-D1E20D1A2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058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D0D98-E0D5-214C-924A-6BCFCD104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AD1E6-077B-5C46-8CF7-BA79FD1AA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ADB71-6E91-8E4E-82F4-4B778B201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CC104D-8D30-854D-92A2-2CF7C6838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ABD4C-A3FA-9945-ACD4-90876A734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782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FE5EA-9FA0-D748-AD58-B910EE343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F6F9E4-555F-874E-9A79-CD66D8A883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C56A18-C3DF-2B40-A6E1-F9E938687A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712B20-E646-1842-B0EF-16C249C81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B8C6DC-49FD-594C-BC35-83FCFB1B6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02F374-934B-FB46-925F-69EB7AEB2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504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7C572-BC1D-0440-A49B-FEE90782A9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B50A4F-BE65-594F-9E7B-1286D2128A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70BC09-7918-B54A-A350-660B77B054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ADC52E-8FF9-AD48-B5BF-45ADC37A12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29326C-EAD7-B746-95A9-05D78C9594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395A3B-85BE-3B49-B847-3E117D1BD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80F8E1-029E-2245-8088-DCA729642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9E3283-CC27-774D-AB45-715735D49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095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22FDB2-C295-A845-A628-3FF1260D6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FEFFEE-A047-3848-9CD1-930601AB1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C25DB9-66D7-8949-9A18-4BADBA066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30EAFC-8BE8-F149-80C3-164739DD2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180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E78FCD-42DD-0140-99EA-74C6EABE7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E446FD-A12B-094D-9156-E137298B1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73B407-852D-DB48-BFCF-67CF400F5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094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59F91-BAF6-3849-9203-BD3DA0AAE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5FBBE1-0A66-F74C-A8CB-7801366A1F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515776-5188-C542-BEF2-CAD45B714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F9A877-7541-894C-95D5-D326A4E67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B80484-6D19-1948-B175-B479D186F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0A339D-C979-2E44-BE43-AF0E42D5A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815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A28568-378E-474F-BAC0-15CE0E08E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320BB6-D5AE-1B45-A0D4-BE1F107734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250297-618F-344C-B577-E4FB6156D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0D2A4F-F77E-C34D-87CE-01D587E32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4F9526-E9D9-6B4A-814F-2BD82A431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5C974F-0CC1-4341-B08F-6CE960F02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43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FAA746-A020-724F-85AE-9FD5A7127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3751C6-02B6-884C-BF0C-217EBEA65E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02B0D6-32CE-524F-8980-36CBCE164F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8064A-9EFA-CA4E-9A01-6B77A1FF9B60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616D89-05C4-9345-9F66-E1A49C3B07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FDAB6E-9DA7-8A4A-8D9E-9B062E15B1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8BFEAC-7FCD-1D43-BFB7-519C1EDDF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70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6911724-7B2C-A944-A4DF-7DC8674896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204"/>
          <a:stretch/>
        </p:blipFill>
        <p:spPr>
          <a:xfrm>
            <a:off x="9739901" y="1119882"/>
            <a:ext cx="1582220" cy="482033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D57C62D-7C3B-0D46-83EB-46E5EA1ACC83}"/>
              </a:ext>
            </a:extLst>
          </p:cNvPr>
          <p:cNvSpPr txBox="1"/>
          <p:nvPr/>
        </p:nvSpPr>
        <p:spPr>
          <a:xfrm>
            <a:off x="1992499" y="2505462"/>
            <a:ext cx="11192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E3C2671-18FA-7041-AE34-30020750812F}"/>
              </a:ext>
            </a:extLst>
          </p:cNvPr>
          <p:cNvSpPr txBox="1"/>
          <p:nvPr/>
        </p:nvSpPr>
        <p:spPr>
          <a:xfrm>
            <a:off x="3285883" y="2505461"/>
            <a:ext cx="1576073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BRD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0434D5-E26E-BC4C-96D2-7BCD3CE07292}"/>
              </a:ext>
            </a:extLst>
          </p:cNvPr>
          <p:cNvSpPr txBox="1"/>
          <p:nvPr/>
        </p:nvSpPr>
        <p:spPr>
          <a:xfrm>
            <a:off x="322874" y="3322980"/>
            <a:ext cx="12795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A9B918-AB73-D840-AFAC-51BFC9ACC946}"/>
              </a:ext>
            </a:extLst>
          </p:cNvPr>
          <p:cNvSpPr txBox="1"/>
          <p:nvPr/>
        </p:nvSpPr>
        <p:spPr>
          <a:xfrm>
            <a:off x="206241" y="4364115"/>
            <a:ext cx="1512786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73D796-D228-944E-BAB3-844B8E286276}"/>
              </a:ext>
            </a:extLst>
          </p:cNvPr>
          <p:cNvSpPr txBox="1"/>
          <p:nvPr/>
        </p:nvSpPr>
        <p:spPr>
          <a:xfrm>
            <a:off x="206241" y="179556"/>
            <a:ext cx="3667992" cy="1569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3199" dirty="0" err="1">
                <a:latin typeface="Arial" panose="020B0604020202020204" pitchFamily="34" charset="0"/>
                <a:cs typeface="Arial" panose="020B0604020202020204" pitchFamily="34" charset="0"/>
              </a:rPr>
              <a:t>Jinjie</a:t>
            </a:r>
            <a:endParaRPr lang="en-US" sz="31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Image ID: 000005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DD654E6-5EC2-4B46-8E34-DA6EF79FE5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5120" y="713840"/>
            <a:ext cx="3987800" cy="5778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C7F9FF7-7555-4046-98B3-7385B67DBF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4733" y="3226679"/>
            <a:ext cx="3162299" cy="80367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FAC7B6-E27C-C240-BDA4-7D3DCAF8EA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9656" y="4234491"/>
            <a:ext cx="3162299" cy="87467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753029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6911724-7B2C-A944-A4DF-7DC8674896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204"/>
          <a:stretch/>
        </p:blipFill>
        <p:spPr>
          <a:xfrm>
            <a:off x="9739901" y="1119882"/>
            <a:ext cx="1582220" cy="482033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D57C62D-7C3B-0D46-83EB-46E5EA1ACC83}"/>
              </a:ext>
            </a:extLst>
          </p:cNvPr>
          <p:cNvSpPr txBox="1"/>
          <p:nvPr/>
        </p:nvSpPr>
        <p:spPr>
          <a:xfrm>
            <a:off x="1992499" y="2505462"/>
            <a:ext cx="11192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E3C2671-18FA-7041-AE34-30020750812F}"/>
              </a:ext>
            </a:extLst>
          </p:cNvPr>
          <p:cNvSpPr txBox="1"/>
          <p:nvPr/>
        </p:nvSpPr>
        <p:spPr>
          <a:xfrm>
            <a:off x="3285883" y="2505461"/>
            <a:ext cx="1576073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BRD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0434D5-E26E-BC4C-96D2-7BCD3CE07292}"/>
              </a:ext>
            </a:extLst>
          </p:cNvPr>
          <p:cNvSpPr txBox="1"/>
          <p:nvPr/>
        </p:nvSpPr>
        <p:spPr>
          <a:xfrm>
            <a:off x="322874" y="3322980"/>
            <a:ext cx="12795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A9B918-AB73-D840-AFAC-51BFC9ACC946}"/>
              </a:ext>
            </a:extLst>
          </p:cNvPr>
          <p:cNvSpPr txBox="1"/>
          <p:nvPr/>
        </p:nvSpPr>
        <p:spPr>
          <a:xfrm>
            <a:off x="206241" y="4364115"/>
            <a:ext cx="1512786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73D796-D228-944E-BAB3-844B8E286276}"/>
              </a:ext>
            </a:extLst>
          </p:cNvPr>
          <p:cNvSpPr txBox="1"/>
          <p:nvPr/>
        </p:nvSpPr>
        <p:spPr>
          <a:xfrm>
            <a:off x="206241" y="179556"/>
            <a:ext cx="4237057" cy="1569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3199" dirty="0" err="1">
                <a:latin typeface="Arial" panose="020B0604020202020204" pitchFamily="34" charset="0"/>
                <a:cs typeface="Arial" panose="020B0604020202020204" pitchFamily="34" charset="0"/>
              </a:rPr>
              <a:t>Jinjie</a:t>
            </a:r>
            <a:endParaRPr lang="en-US" sz="31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Image ID: 0000055,56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0050E73-3491-8749-94EC-CD95F498F4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3883" y="497478"/>
            <a:ext cx="3237297" cy="31310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7F88408-9D8A-5D42-839C-A0B7385E32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2039" y="3317445"/>
            <a:ext cx="3162299" cy="80434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719057B-B3C4-D948-B1EB-00107874F6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V="1">
            <a:off x="6396015" y="3556665"/>
            <a:ext cx="2853031" cy="28692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79CD216-77A7-F54F-BDF5-C8C5FEB9CB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5310" y="4296771"/>
            <a:ext cx="3149028" cy="67733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5706386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EDFFE2D-D452-E84A-A060-2C6ED9DA96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44012" y="1119882"/>
            <a:ext cx="3400042" cy="486481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6911724-7B2C-A944-A4DF-7DC8674896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204"/>
          <a:stretch/>
        </p:blipFill>
        <p:spPr>
          <a:xfrm>
            <a:off x="9739901" y="1119882"/>
            <a:ext cx="1582220" cy="482033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3CD4FAC-F9EF-2440-AB5E-C64E1D9E5A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2317" y="3098965"/>
            <a:ext cx="3162300" cy="8763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7B7380A-6455-174D-8FEF-A73A2327A3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22316" y="4149355"/>
            <a:ext cx="3162299" cy="85779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D57C62D-7C3B-0D46-83EB-46E5EA1ACC83}"/>
              </a:ext>
            </a:extLst>
          </p:cNvPr>
          <p:cNvSpPr txBox="1"/>
          <p:nvPr/>
        </p:nvSpPr>
        <p:spPr>
          <a:xfrm>
            <a:off x="2092789" y="2427273"/>
            <a:ext cx="11192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E3C2671-18FA-7041-AE34-30020750812F}"/>
              </a:ext>
            </a:extLst>
          </p:cNvPr>
          <p:cNvSpPr txBox="1"/>
          <p:nvPr/>
        </p:nvSpPr>
        <p:spPr>
          <a:xfrm>
            <a:off x="3386173" y="2427272"/>
            <a:ext cx="1576072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siBRD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0434D5-E26E-BC4C-96D2-7BCD3CE07292}"/>
              </a:ext>
            </a:extLst>
          </p:cNvPr>
          <p:cNvSpPr txBox="1"/>
          <p:nvPr/>
        </p:nvSpPr>
        <p:spPr>
          <a:xfrm>
            <a:off x="423164" y="3244791"/>
            <a:ext cx="1279517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A9B918-AB73-D840-AFAC-51BFC9ACC946}"/>
              </a:ext>
            </a:extLst>
          </p:cNvPr>
          <p:cNvSpPr txBox="1"/>
          <p:nvPr/>
        </p:nvSpPr>
        <p:spPr>
          <a:xfrm>
            <a:off x="306531" y="4285926"/>
            <a:ext cx="1512786" cy="584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949A90-D8DB-714A-9DD9-AC6664E29FAD}"/>
              </a:ext>
            </a:extLst>
          </p:cNvPr>
          <p:cNvSpPr txBox="1"/>
          <p:nvPr/>
        </p:nvSpPr>
        <p:spPr>
          <a:xfrm>
            <a:off x="206241" y="179556"/>
            <a:ext cx="3667992" cy="1569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3199" dirty="0" err="1">
                <a:latin typeface="Arial" panose="020B0604020202020204" pitchFamily="34" charset="0"/>
                <a:cs typeface="Arial" panose="020B0604020202020204" pitchFamily="34" charset="0"/>
              </a:rPr>
              <a:t>Jinjie</a:t>
            </a:r>
            <a:endParaRPr lang="en-US" sz="31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Image ID: 0000054</a:t>
            </a:r>
          </a:p>
        </p:txBody>
      </p:sp>
    </p:spTree>
    <p:extLst>
      <p:ext uri="{BB962C8B-B14F-4D97-AF65-F5344CB8AC3E}">
        <p14:creationId xmlns:p14="http://schemas.microsoft.com/office/powerpoint/2010/main" val="22748131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6911724-7B2C-A944-A4DF-7DC8674896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204"/>
          <a:stretch/>
        </p:blipFill>
        <p:spPr>
          <a:xfrm>
            <a:off x="9739901" y="1119882"/>
            <a:ext cx="1582220" cy="482033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9949A90-D8DB-714A-9DD9-AC6664E29FAD}"/>
              </a:ext>
            </a:extLst>
          </p:cNvPr>
          <p:cNvSpPr txBox="1"/>
          <p:nvPr/>
        </p:nvSpPr>
        <p:spPr>
          <a:xfrm>
            <a:off x="206241" y="179556"/>
            <a:ext cx="3667992" cy="1569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Work Area: </a:t>
            </a:r>
            <a:r>
              <a:rPr lang="en-US" sz="3199" dirty="0" err="1">
                <a:latin typeface="Arial" panose="020B0604020202020204" pitchFamily="34" charset="0"/>
                <a:cs typeface="Arial" panose="020B0604020202020204" pitchFamily="34" charset="0"/>
              </a:rPr>
              <a:t>Jinjie</a:t>
            </a:r>
            <a:endParaRPr lang="en-US" sz="3199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199" dirty="0">
                <a:latin typeface="Arial" panose="020B0604020202020204" pitchFamily="34" charset="0"/>
                <a:cs typeface="Arial" panose="020B0604020202020204" pitchFamily="34" charset="0"/>
              </a:rPr>
              <a:t>Image ID: 0000068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4FD3C20-CB0F-D142-9E55-97F04A0746F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595" t="58237" r="8497" b="26758"/>
          <a:stretch/>
        </p:blipFill>
        <p:spPr>
          <a:xfrm>
            <a:off x="2188897" y="4279035"/>
            <a:ext cx="2157573" cy="47261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4DBCE05-66E8-5A4E-83CE-1C632239933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595" t="27247" r="11493" b="60357"/>
          <a:stretch/>
        </p:blipFill>
        <p:spPr>
          <a:xfrm>
            <a:off x="2179264" y="4913960"/>
            <a:ext cx="2157573" cy="39041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B16DDFF-D077-204B-BF57-CC09460EC6AE}"/>
              </a:ext>
            </a:extLst>
          </p:cNvPr>
          <p:cNvSpPr txBox="1"/>
          <p:nvPr/>
        </p:nvSpPr>
        <p:spPr>
          <a:xfrm rot="16200000">
            <a:off x="1795620" y="3152087"/>
            <a:ext cx="14013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E8A542-C357-9E40-8F3C-BBFAD59E69FF}"/>
              </a:ext>
            </a:extLst>
          </p:cNvPr>
          <p:cNvSpPr txBox="1"/>
          <p:nvPr/>
        </p:nvSpPr>
        <p:spPr>
          <a:xfrm rot="16200000">
            <a:off x="2371305" y="3237848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78D23A8-F2ED-5E45-9A84-087765B5614E}"/>
              </a:ext>
            </a:extLst>
          </p:cNvPr>
          <p:cNvSpPr txBox="1"/>
          <p:nvPr/>
        </p:nvSpPr>
        <p:spPr>
          <a:xfrm rot="16200000">
            <a:off x="2867344" y="3227242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8C1384F-37B1-514F-A04F-B55DBCAD9A0E}"/>
              </a:ext>
            </a:extLst>
          </p:cNvPr>
          <p:cNvSpPr txBox="1"/>
          <p:nvPr/>
        </p:nvSpPr>
        <p:spPr>
          <a:xfrm rot="16200000">
            <a:off x="3434140" y="3227242"/>
            <a:ext cx="12298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BRD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A00ECBC-2053-C14E-AD3A-8ADF0CDF07B0}"/>
              </a:ext>
            </a:extLst>
          </p:cNvPr>
          <p:cNvSpPr txBox="1"/>
          <p:nvPr/>
        </p:nvSpPr>
        <p:spPr>
          <a:xfrm>
            <a:off x="869879" y="4878337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2E53779-FC32-1544-ACCD-30F389AAA493}"/>
              </a:ext>
            </a:extLst>
          </p:cNvPr>
          <p:cNvSpPr txBox="1"/>
          <p:nvPr/>
        </p:nvSpPr>
        <p:spPr>
          <a:xfrm>
            <a:off x="879511" y="4279035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8CB137B-81D4-3944-A936-83A5CE6C977F}"/>
              </a:ext>
            </a:extLst>
          </p:cNvPr>
          <p:cNvSpPr txBox="1"/>
          <p:nvPr/>
        </p:nvSpPr>
        <p:spPr>
          <a:xfrm>
            <a:off x="2817215" y="2121874"/>
            <a:ext cx="9220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465550-5DC7-2647-817D-F9F60EEFEBEA}"/>
              </a:ext>
            </a:extLst>
          </p:cNvPr>
          <p:cNvSpPr txBox="1"/>
          <p:nvPr/>
        </p:nvSpPr>
        <p:spPr>
          <a:xfrm>
            <a:off x="1066682" y="3174353"/>
            <a:ext cx="9557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72hr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C7401D8-D9A6-0C4D-B308-5D96AE7D2A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2291" y="1175374"/>
            <a:ext cx="4567066" cy="4661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7158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57</Words>
  <Application>Microsoft Macintosh PowerPoint</Application>
  <PresentationFormat>Widescreen</PresentationFormat>
  <Paragraphs>3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7</cp:revision>
  <dcterms:created xsi:type="dcterms:W3CDTF">2019-11-24T17:05:03Z</dcterms:created>
  <dcterms:modified xsi:type="dcterms:W3CDTF">2019-11-24T18:35:21Z</dcterms:modified>
</cp:coreProperties>
</file>